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Magn%20Diacetat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415250725238295E-2"/>
          <c:y val="3.0405963452119052E-2"/>
          <c:w val="0.84299179444674677"/>
          <c:h val="0.70805254938526918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Graph!$D$21</c:f>
              <c:strCache>
                <c:ptCount val="1"/>
                <c:pt idx="0">
                  <c:v>400 µg/ml</c:v>
                </c:pt>
              </c:strCache>
            </c:strRef>
          </c:tx>
          <c:spPr>
            <a:solidFill>
              <a:schemeClr val="accent3"/>
            </a:solidFill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1DA3-407B-AF14-26EF688C5974}"/>
              </c:ext>
            </c:extLst>
          </c:dPt>
          <c:errBars>
            <c:errBarType val="both"/>
            <c:errValType val="cust"/>
            <c:noEndCap val="0"/>
            <c:plus>
              <c:numRef>
                <c:f>'[1]Magn diacetato'!$F$22:$F$36</c:f>
                <c:numCache>
                  <c:formatCode>General</c:formatCode>
                  <c:ptCount val="15"/>
                  <c:pt idx="0">
                    <c:v>3.1830204558765094</c:v>
                  </c:pt>
                  <c:pt idx="1">
                    <c:v>6.9948369339777026</c:v>
                  </c:pt>
                  <c:pt idx="2">
                    <c:v>2.5322380227615144</c:v>
                  </c:pt>
                  <c:pt idx="3">
                    <c:v>6.6414140506606349</c:v>
                  </c:pt>
                  <c:pt idx="4">
                    <c:v>2.1430335024428806</c:v>
                  </c:pt>
                  <c:pt idx="5">
                    <c:v>5.2673283850067083</c:v>
                  </c:pt>
                  <c:pt idx="6">
                    <c:v>2.0429317217479035</c:v>
                  </c:pt>
                  <c:pt idx="7">
                    <c:v>0</c:v>
                  </c:pt>
                  <c:pt idx="8">
                    <c:v>0.37248404463846585</c:v>
                  </c:pt>
                  <c:pt idx="9">
                    <c:v>6.3457535826583324</c:v>
                  </c:pt>
                  <c:pt idx="10">
                    <c:v>1.9092270806535141</c:v>
                  </c:pt>
                  <c:pt idx="11">
                    <c:v>4.7237749297332963</c:v>
                  </c:pt>
                  <c:pt idx="12">
                    <c:v>3.3333333333333357</c:v>
                  </c:pt>
                  <c:pt idx="13">
                    <c:v>2.0429317217479035</c:v>
                  </c:pt>
                  <c:pt idx="14">
                    <c:v>2.51021856169403</c:v>
                  </c:pt>
                </c:numCache>
              </c:numRef>
            </c:plus>
            <c:minus>
              <c:numRef>
                <c:f>'[1]Magn diacetato'!$F$22:$F$36</c:f>
                <c:numCache>
                  <c:formatCode>General</c:formatCode>
                  <c:ptCount val="15"/>
                  <c:pt idx="0">
                    <c:v>3.1830204558765094</c:v>
                  </c:pt>
                  <c:pt idx="1">
                    <c:v>6.9948369339777026</c:v>
                  </c:pt>
                  <c:pt idx="2">
                    <c:v>2.5322380227615144</c:v>
                  </c:pt>
                  <c:pt idx="3">
                    <c:v>6.6414140506606349</c:v>
                  </c:pt>
                  <c:pt idx="4">
                    <c:v>2.1430335024428806</c:v>
                  </c:pt>
                  <c:pt idx="5">
                    <c:v>5.2673283850067083</c:v>
                  </c:pt>
                  <c:pt idx="6">
                    <c:v>2.0429317217479035</c:v>
                  </c:pt>
                  <c:pt idx="7">
                    <c:v>0</c:v>
                  </c:pt>
                  <c:pt idx="8">
                    <c:v>0.37248404463846585</c:v>
                  </c:pt>
                  <c:pt idx="9">
                    <c:v>6.3457535826583324</c:v>
                  </c:pt>
                  <c:pt idx="10">
                    <c:v>1.9092270806535141</c:v>
                  </c:pt>
                  <c:pt idx="11">
                    <c:v>4.7237749297332963</c:v>
                  </c:pt>
                  <c:pt idx="12">
                    <c:v>3.3333333333333357</c:v>
                  </c:pt>
                  <c:pt idx="13">
                    <c:v>2.0429317217479035</c:v>
                  </c:pt>
                  <c:pt idx="14">
                    <c:v>2.51021856169403</c:v>
                  </c:pt>
                </c:numCache>
              </c:numRef>
            </c:minus>
          </c:errBars>
          <c:cat>
            <c:strRef>
              <c:f>Graph!$C$22:$C$36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D$22:$D$36</c:f>
              <c:numCache>
                <c:formatCode>0.00</c:formatCode>
                <c:ptCount val="15"/>
                <c:pt idx="0">
                  <c:v>80.510101010101025</c:v>
                </c:pt>
                <c:pt idx="1">
                  <c:v>84.32900432900432</c:v>
                </c:pt>
                <c:pt idx="2">
                  <c:v>78.265107212475627</c:v>
                </c:pt>
                <c:pt idx="3">
                  <c:v>94.20289855072464</c:v>
                </c:pt>
                <c:pt idx="4">
                  <c:v>83.777777777777786</c:v>
                </c:pt>
                <c:pt idx="5">
                  <c:v>82.758620689655174</c:v>
                </c:pt>
                <c:pt idx="6">
                  <c:v>83.179487179487182</c:v>
                </c:pt>
                <c:pt idx="7">
                  <c:v>90.666666666666671</c:v>
                </c:pt>
                <c:pt idx="8">
                  <c:v>78.064516129032242</c:v>
                </c:pt>
                <c:pt idx="9">
                  <c:v>91.425120772946869</c:v>
                </c:pt>
                <c:pt idx="10">
                  <c:v>86.772486772486786</c:v>
                </c:pt>
                <c:pt idx="11">
                  <c:v>81.818181818181813</c:v>
                </c:pt>
                <c:pt idx="12">
                  <c:v>87.777777777777786</c:v>
                </c:pt>
                <c:pt idx="13">
                  <c:v>83.179487179487182</c:v>
                </c:pt>
                <c:pt idx="14">
                  <c:v>82.6086956521739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1E7-419E-A01D-5CFBECDB546D}"/>
            </c:ext>
          </c:extLst>
        </c:ser>
        <c:ser>
          <c:idx val="6"/>
          <c:order val="1"/>
          <c:tx>
            <c:strRef>
              <c:f>Graph!$F$21</c:f>
              <c:strCache>
                <c:ptCount val="1"/>
                <c:pt idx="0">
                  <c:v>200 µg/ml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]Magn diacetato'!$J$22:$J$36</c:f>
                <c:numCache>
                  <c:formatCode>General</c:formatCode>
                  <c:ptCount val="15"/>
                  <c:pt idx="0">
                    <c:v>7.576787808736797</c:v>
                  </c:pt>
                  <c:pt idx="1">
                    <c:v>4.3198134758324098</c:v>
                  </c:pt>
                  <c:pt idx="2">
                    <c:v>2.5322380227615144</c:v>
                  </c:pt>
                  <c:pt idx="3">
                    <c:v>7.5306556850820741</c:v>
                  </c:pt>
                  <c:pt idx="4">
                    <c:v>4.0184758488944796</c:v>
                  </c:pt>
                  <c:pt idx="5">
                    <c:v>1.9908629972056076</c:v>
                  </c:pt>
                  <c:pt idx="6">
                    <c:v>4.085863443495815</c:v>
                  </c:pt>
                  <c:pt idx="7">
                    <c:v>2.3094010767584865</c:v>
                  </c:pt>
                  <c:pt idx="8">
                    <c:v>4.2214858392359655</c:v>
                  </c:pt>
                  <c:pt idx="9">
                    <c:v>4.3478260869565162</c:v>
                  </c:pt>
                  <c:pt idx="10">
                    <c:v>1.9092270806535141</c:v>
                  </c:pt>
                  <c:pt idx="11">
                    <c:v>10.147368367575234</c:v>
                  </c:pt>
                  <c:pt idx="12">
                    <c:v>3.3333333333333357</c:v>
                  </c:pt>
                  <c:pt idx="13">
                    <c:v>7.6155141144130605</c:v>
                  </c:pt>
                  <c:pt idx="14">
                    <c:v>4.3478260869565233</c:v>
                  </c:pt>
                </c:numCache>
              </c:numRef>
            </c:plus>
            <c:minus>
              <c:numRef>
                <c:f>'[1]Magn diacetato'!$J$22:$J$36</c:f>
                <c:numCache>
                  <c:formatCode>General</c:formatCode>
                  <c:ptCount val="15"/>
                  <c:pt idx="0">
                    <c:v>7.576787808736797</c:v>
                  </c:pt>
                  <c:pt idx="1">
                    <c:v>4.3198134758324098</c:v>
                  </c:pt>
                  <c:pt idx="2">
                    <c:v>2.5322380227615144</c:v>
                  </c:pt>
                  <c:pt idx="3">
                    <c:v>7.5306556850820741</c:v>
                  </c:pt>
                  <c:pt idx="4">
                    <c:v>4.0184758488944796</c:v>
                  </c:pt>
                  <c:pt idx="5">
                    <c:v>1.9908629972056076</c:v>
                  </c:pt>
                  <c:pt idx="6">
                    <c:v>4.085863443495815</c:v>
                  </c:pt>
                  <c:pt idx="7">
                    <c:v>2.3094010767584865</c:v>
                  </c:pt>
                  <c:pt idx="8">
                    <c:v>4.2214858392359655</c:v>
                  </c:pt>
                  <c:pt idx="9">
                    <c:v>4.3478260869565162</c:v>
                  </c:pt>
                  <c:pt idx="10">
                    <c:v>1.9092270806535141</c:v>
                  </c:pt>
                  <c:pt idx="11">
                    <c:v>10.147368367575234</c:v>
                  </c:pt>
                  <c:pt idx="12">
                    <c:v>3.3333333333333357</c:v>
                  </c:pt>
                  <c:pt idx="13">
                    <c:v>7.6155141144130605</c:v>
                  </c:pt>
                  <c:pt idx="14">
                    <c:v>4.3478260869565233</c:v>
                  </c:pt>
                </c:numCache>
              </c:numRef>
            </c:minus>
          </c:errBars>
          <c:cat>
            <c:strRef>
              <c:f>Graph!$C$22:$C$36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F$22:$F$36</c:f>
              <c:numCache>
                <c:formatCode>0.00</c:formatCode>
                <c:ptCount val="15"/>
                <c:pt idx="0">
                  <c:v>83.232323232323239</c:v>
                </c:pt>
                <c:pt idx="1">
                  <c:v>92.27994227994229</c:v>
                </c:pt>
                <c:pt idx="2">
                  <c:v>81.871345029239762</c:v>
                </c:pt>
                <c:pt idx="3">
                  <c:v>92.753623188405797</c:v>
                </c:pt>
                <c:pt idx="4">
                  <c:v>82.444444444444443</c:v>
                </c:pt>
                <c:pt idx="5">
                  <c:v>77.011494252873561</c:v>
                </c:pt>
                <c:pt idx="6">
                  <c:v>89.641025641025635</c:v>
                </c:pt>
                <c:pt idx="7">
                  <c:v>91.999999999999986</c:v>
                </c:pt>
                <c:pt idx="8">
                  <c:v>80.215053763440849</c:v>
                </c:pt>
                <c:pt idx="9">
                  <c:v>94.384057971014499</c:v>
                </c:pt>
                <c:pt idx="10">
                  <c:v>90.388007054673722</c:v>
                </c:pt>
                <c:pt idx="11">
                  <c:v>87.272727272727266</c:v>
                </c:pt>
                <c:pt idx="12">
                  <c:v>96.666666666666671</c:v>
                </c:pt>
                <c:pt idx="13">
                  <c:v>89.641025641025635</c:v>
                </c:pt>
                <c:pt idx="14">
                  <c:v>88.4057971014492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1E7-419E-A01D-5CFBECDB546D}"/>
            </c:ext>
          </c:extLst>
        </c:ser>
        <c:ser>
          <c:idx val="3"/>
          <c:order val="2"/>
          <c:tx>
            <c:strRef>
              <c:f>Graph!$H$21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I$22:$I$36</c:f>
                <c:numCache>
                  <c:formatCode>General</c:formatCode>
                  <c:ptCount val="15"/>
                  <c:pt idx="0">
                    <c:v>3.9367220931493119</c:v>
                  </c:pt>
                  <c:pt idx="1">
                    <c:v>7.6801811623477638</c:v>
                  </c:pt>
                  <c:pt idx="2">
                    <c:v>2.5322380227615144</c:v>
                  </c:pt>
                  <c:pt idx="3">
                    <c:v>5.020437123388044</c:v>
                  </c:pt>
                  <c:pt idx="4">
                    <c:v>2.1169509870286305</c:v>
                  </c:pt>
                  <c:pt idx="5">
                    <c:v>1.9908629972056076</c:v>
                  </c:pt>
                  <c:pt idx="6">
                    <c:v>2.1000610491736622</c:v>
                  </c:pt>
                  <c:pt idx="7">
                    <c:v>2.3094010767584865</c:v>
                  </c:pt>
                  <c:pt idx="8">
                    <c:v>0.49664539285128234</c:v>
                  </c:pt>
                  <c:pt idx="9">
                    <c:v>2.4124377240867396</c:v>
                  </c:pt>
                  <c:pt idx="10">
                    <c:v>1.9092270806535141</c:v>
                  </c:pt>
                  <c:pt idx="11">
                    <c:v>1.6689607719048773</c:v>
                  </c:pt>
                  <c:pt idx="12">
                    <c:v>0</c:v>
                  </c:pt>
                  <c:pt idx="13">
                    <c:v>6.5325765370960482</c:v>
                  </c:pt>
                  <c:pt idx="14">
                    <c:v>2.51021856169403</c:v>
                  </c:pt>
                </c:numCache>
              </c:numRef>
            </c:plus>
            <c:minus>
              <c:numRef>
                <c:f>Graph!$I$22:$I$36</c:f>
                <c:numCache>
                  <c:formatCode>General</c:formatCode>
                  <c:ptCount val="15"/>
                  <c:pt idx="0">
                    <c:v>3.9367220931493119</c:v>
                  </c:pt>
                  <c:pt idx="1">
                    <c:v>7.6801811623477638</c:v>
                  </c:pt>
                  <c:pt idx="2">
                    <c:v>2.5322380227615144</c:v>
                  </c:pt>
                  <c:pt idx="3">
                    <c:v>5.020437123388044</c:v>
                  </c:pt>
                  <c:pt idx="4">
                    <c:v>2.1169509870286305</c:v>
                  </c:pt>
                  <c:pt idx="5">
                    <c:v>1.9908629972056076</c:v>
                  </c:pt>
                  <c:pt idx="6">
                    <c:v>2.1000610491736622</c:v>
                  </c:pt>
                  <c:pt idx="7">
                    <c:v>2.3094010767584865</c:v>
                  </c:pt>
                  <c:pt idx="8">
                    <c:v>0.49664539285128234</c:v>
                  </c:pt>
                  <c:pt idx="9">
                    <c:v>2.4124377240867396</c:v>
                  </c:pt>
                  <c:pt idx="10">
                    <c:v>1.9092270806535141</c:v>
                  </c:pt>
                  <c:pt idx="11">
                    <c:v>1.6689607719048773</c:v>
                  </c:pt>
                  <c:pt idx="12">
                    <c:v>0</c:v>
                  </c:pt>
                  <c:pt idx="13">
                    <c:v>6.5325765370960482</c:v>
                  </c:pt>
                  <c:pt idx="14">
                    <c:v>2.51021856169403</c:v>
                  </c:pt>
                </c:numCache>
              </c:numRef>
            </c:minus>
          </c:errBars>
          <c:cat>
            <c:strRef>
              <c:f>Graph!$C$22:$C$36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H$22:$H$36</c:f>
              <c:numCache>
                <c:formatCode>General</c:formatCode>
                <c:ptCount val="15"/>
                <c:pt idx="0">
                  <c:v>81.843434343434353</c:v>
                </c:pt>
                <c:pt idx="1">
                  <c:v>90.685425685425685</c:v>
                </c:pt>
                <c:pt idx="2">
                  <c:v>81.871345029239762</c:v>
                </c:pt>
                <c:pt idx="3">
                  <c:v>94.20289855072464</c:v>
                </c:pt>
                <c:pt idx="4">
                  <c:v>89.222222222222243</c:v>
                </c:pt>
                <c:pt idx="5">
                  <c:v>85.057471264367805</c:v>
                </c:pt>
                <c:pt idx="6">
                  <c:v>87.025641025641036</c:v>
                </c:pt>
                <c:pt idx="7">
                  <c:v>90.666666666666671</c:v>
                </c:pt>
                <c:pt idx="8">
                  <c:v>73.620071684587813</c:v>
                </c:pt>
                <c:pt idx="9">
                  <c:v>92.874396135265712</c:v>
                </c:pt>
                <c:pt idx="10">
                  <c:v>90.388007054673722</c:v>
                </c:pt>
                <c:pt idx="11">
                  <c:v>81.717171717171709</c:v>
                </c:pt>
                <c:pt idx="12">
                  <c:v>93.333333333333329</c:v>
                </c:pt>
                <c:pt idx="13">
                  <c:v>84.461538461538467</c:v>
                </c:pt>
                <c:pt idx="14">
                  <c:v>89.8550724637681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1E7-419E-A01D-5CFBECDB546D}"/>
            </c:ext>
          </c:extLst>
        </c:ser>
        <c:ser>
          <c:idx val="7"/>
          <c:order val="3"/>
          <c:tx>
            <c:strRef>
              <c:f>Graph!$J$21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FF00FF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raph!$K$22:$K$36</c:f>
                <c:numCache>
                  <c:formatCode>General</c:formatCode>
                  <c:ptCount val="15"/>
                  <c:pt idx="0">
                    <c:v>7.576787808736797</c:v>
                  </c:pt>
                  <c:pt idx="1">
                    <c:v>4.3198134758324098</c:v>
                  </c:pt>
                  <c:pt idx="2">
                    <c:v>2.5322380227615144</c:v>
                  </c:pt>
                  <c:pt idx="3">
                    <c:v>7.5306556850820741</c:v>
                  </c:pt>
                  <c:pt idx="4">
                    <c:v>4.0184758488944796</c:v>
                  </c:pt>
                  <c:pt idx="5">
                    <c:v>1.9908629972056076</c:v>
                  </c:pt>
                  <c:pt idx="6">
                    <c:v>4.085863443495815</c:v>
                  </c:pt>
                  <c:pt idx="7">
                    <c:v>2.3094010767584865</c:v>
                  </c:pt>
                  <c:pt idx="8">
                    <c:v>4.2214858392359655</c:v>
                  </c:pt>
                  <c:pt idx="9">
                    <c:v>4.3478260869565162</c:v>
                  </c:pt>
                  <c:pt idx="10">
                    <c:v>1.9092270806535141</c:v>
                  </c:pt>
                  <c:pt idx="11">
                    <c:v>10.147368367575234</c:v>
                  </c:pt>
                  <c:pt idx="12">
                    <c:v>3.3333333333333357</c:v>
                  </c:pt>
                  <c:pt idx="13">
                    <c:v>7.6155141144130605</c:v>
                  </c:pt>
                  <c:pt idx="14">
                    <c:v>4.3478260869565233</c:v>
                  </c:pt>
                </c:numCache>
              </c:numRef>
            </c:plus>
            <c:minus>
              <c:numRef>
                <c:f>Graph!$K$22:$K$36</c:f>
                <c:numCache>
                  <c:formatCode>General</c:formatCode>
                  <c:ptCount val="15"/>
                  <c:pt idx="0">
                    <c:v>7.576787808736797</c:v>
                  </c:pt>
                  <c:pt idx="1">
                    <c:v>4.3198134758324098</c:v>
                  </c:pt>
                  <c:pt idx="2">
                    <c:v>2.5322380227615144</c:v>
                  </c:pt>
                  <c:pt idx="3">
                    <c:v>7.5306556850820741</c:v>
                  </c:pt>
                  <c:pt idx="4">
                    <c:v>4.0184758488944796</c:v>
                  </c:pt>
                  <c:pt idx="5">
                    <c:v>1.9908629972056076</c:v>
                  </c:pt>
                  <c:pt idx="6">
                    <c:v>4.085863443495815</c:v>
                  </c:pt>
                  <c:pt idx="7">
                    <c:v>2.3094010767584865</c:v>
                  </c:pt>
                  <c:pt idx="8">
                    <c:v>4.2214858392359655</c:v>
                  </c:pt>
                  <c:pt idx="9">
                    <c:v>4.3478260869565162</c:v>
                  </c:pt>
                  <c:pt idx="10">
                    <c:v>1.9092270806535141</c:v>
                  </c:pt>
                  <c:pt idx="11">
                    <c:v>10.147368367575234</c:v>
                  </c:pt>
                  <c:pt idx="12">
                    <c:v>3.3333333333333357</c:v>
                  </c:pt>
                  <c:pt idx="13">
                    <c:v>7.6155141144130605</c:v>
                  </c:pt>
                  <c:pt idx="14">
                    <c:v>4.3478260869565233</c:v>
                  </c:pt>
                </c:numCache>
              </c:numRef>
            </c:minus>
          </c:errBars>
          <c:cat>
            <c:strRef>
              <c:f>Graph!$C$22:$C$36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Graph!$J$22:$J$36</c:f>
              <c:numCache>
                <c:formatCode>0.00</c:formatCode>
                <c:ptCount val="15"/>
                <c:pt idx="0">
                  <c:v>77.787878787878796</c:v>
                </c:pt>
                <c:pt idx="1">
                  <c:v>90.613275613275619</c:v>
                </c:pt>
                <c:pt idx="2">
                  <c:v>81.871345029239762</c:v>
                </c:pt>
                <c:pt idx="3">
                  <c:v>91.304347826086953</c:v>
                </c:pt>
                <c:pt idx="4">
                  <c:v>83.777777777777786</c:v>
                </c:pt>
                <c:pt idx="5">
                  <c:v>85.057471264367805</c:v>
                </c:pt>
                <c:pt idx="6">
                  <c:v>79.282051282051285</c:v>
                </c:pt>
                <c:pt idx="7">
                  <c:v>90.666666666666671</c:v>
                </c:pt>
                <c:pt idx="8">
                  <c:v>75.770609318996421</c:v>
                </c:pt>
                <c:pt idx="9">
                  <c:v>100</c:v>
                </c:pt>
                <c:pt idx="10">
                  <c:v>90.388007054673722</c:v>
                </c:pt>
                <c:pt idx="11">
                  <c:v>87.474747474747474</c:v>
                </c:pt>
                <c:pt idx="12">
                  <c:v>93.333333333333329</c:v>
                </c:pt>
                <c:pt idx="13">
                  <c:v>88.410256410256409</c:v>
                </c:pt>
                <c:pt idx="14">
                  <c:v>86.9565217391304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21E7-419E-A01D-5CFBECDB546D}"/>
            </c:ext>
          </c:extLst>
        </c:ser>
        <c:ser>
          <c:idx val="0"/>
          <c:order val="4"/>
          <c:tx>
            <c:strRef>
              <c:f>Graph!$L$21</c:f>
              <c:strCache>
                <c:ptCount val="1"/>
                <c:pt idx="0">
                  <c:v>0 µg/ml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Graph!$L$22:$L$36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DA3-407B-AF14-26EF688C59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3828104"/>
        <c:axId val="343827320"/>
      </c:barChart>
      <c:catAx>
        <c:axId val="343828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5400000" vert="horz"/>
          <a:lstStyle/>
          <a:p>
            <a:pPr>
              <a:defRPr/>
            </a:pPr>
            <a:endParaRPr lang="it-IT"/>
          </a:p>
        </c:txPr>
        <c:crossAx val="343827320"/>
        <c:crosses val="autoZero"/>
        <c:auto val="1"/>
        <c:lblAlgn val="ctr"/>
        <c:lblOffset val="100"/>
        <c:noMultiLvlLbl val="0"/>
      </c:catAx>
      <c:valAx>
        <c:axId val="343827320"/>
        <c:scaling>
          <c:orientation val="minMax"/>
          <c:max val="1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Colony diameter (% relative to control)</a:t>
                </a:r>
              </a:p>
            </c:rich>
          </c:tx>
          <c:layout>
            <c:manualLayout>
              <c:xMode val="edge"/>
              <c:yMode val="edge"/>
              <c:x val="1.5320964319718374E-2"/>
              <c:y val="0.1703486102698701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3438281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bg1"/>
      </a:solidFill>
    </a:ln>
  </c:spPr>
  <c:txPr>
    <a:bodyPr/>
    <a:lstStyle/>
    <a:p>
      <a:pPr>
        <a:defRPr sz="800"/>
      </a:pPr>
      <a:endParaRPr lang="it-IT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368</cdr:x>
      <cdr:y>0.14584</cdr:y>
    </cdr:from>
    <cdr:to>
      <cdr:x>0.12105</cdr:x>
      <cdr:y>0.24648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485765" y="676288"/>
          <a:ext cx="609615" cy="4666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b b</a:t>
          </a:r>
          <a:r>
            <a:rPr lang="fr-FR" sz="1100"/>
            <a:t> </a:t>
          </a:r>
        </a:p>
      </cdr:txBody>
    </cdr:sp>
  </cdr:relSizeAnchor>
  <cdr:relSizeAnchor xmlns:cdr="http://schemas.openxmlformats.org/drawingml/2006/chartDrawing">
    <cdr:from>
      <cdr:x>0.09263</cdr:x>
      <cdr:y>0.09859</cdr:y>
    </cdr:from>
    <cdr:to>
      <cdr:x>0.13579</cdr:x>
      <cdr:y>0.15405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838200" y="457192"/>
          <a:ext cx="390544" cy="2571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1158</cdr:x>
      <cdr:y>0.10065</cdr:y>
    </cdr:from>
    <cdr:to>
      <cdr:x>0.22842</cdr:x>
      <cdr:y>0.19924</cdr:y>
    </cdr:to>
    <cdr:sp macro="" textlink="">
      <cdr:nvSpPr>
        <cdr:cNvPr id="5" name="CasellaDiTesto 4"/>
        <cdr:cNvSpPr txBox="1"/>
      </cdr:nvSpPr>
      <cdr:spPr>
        <a:xfrm xmlns:a="http://schemas.openxmlformats.org/drawingml/2006/main">
          <a:off x="1009649" y="466725"/>
          <a:ext cx="1057276" cy="457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 a a</a:t>
          </a:r>
          <a:r>
            <a:rPr lang="fr-FR" sz="1100"/>
            <a:t>	 </a:t>
          </a:r>
        </a:p>
      </cdr:txBody>
    </cdr:sp>
  </cdr:relSizeAnchor>
  <cdr:relSizeAnchor xmlns:cdr="http://schemas.openxmlformats.org/drawingml/2006/chartDrawing">
    <cdr:from>
      <cdr:x>0.15053</cdr:x>
      <cdr:y>0.1027</cdr:y>
    </cdr:from>
    <cdr:to>
      <cdr:x>0.17579</cdr:x>
      <cdr:y>0.14378</cdr:y>
    </cdr:to>
    <cdr:sp macro="" textlink="">
      <cdr:nvSpPr>
        <cdr:cNvPr id="6" name="CasellaDiTesto 5"/>
        <cdr:cNvSpPr txBox="1"/>
      </cdr:nvSpPr>
      <cdr:spPr>
        <a:xfrm xmlns:a="http://schemas.openxmlformats.org/drawingml/2006/main">
          <a:off x="1362075" y="476252"/>
          <a:ext cx="228571" cy="1905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6842</cdr:x>
      <cdr:y>0.1787</cdr:y>
    </cdr:from>
    <cdr:to>
      <cdr:x>0.26632</cdr:x>
      <cdr:y>0.24032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1523999" y="828675"/>
          <a:ext cx="88582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b b </a:t>
          </a:r>
        </a:p>
      </cdr:txBody>
    </cdr:sp>
  </cdr:relSizeAnchor>
  <cdr:relSizeAnchor xmlns:cdr="http://schemas.openxmlformats.org/drawingml/2006/chartDrawing">
    <cdr:from>
      <cdr:x>0.20526</cdr:x>
      <cdr:y>0.1027</cdr:y>
    </cdr:from>
    <cdr:to>
      <cdr:x>0.23158</cdr:x>
      <cdr:y>0.14994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1857332" y="476260"/>
          <a:ext cx="238163" cy="2190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2632</cdr:x>
      <cdr:y>0.09859</cdr:y>
    </cdr:from>
    <cdr:to>
      <cdr:x>0.29579</cdr:x>
      <cdr:y>0.152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2047874" y="457200"/>
          <a:ext cx="628651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 a a </a:t>
          </a:r>
        </a:p>
      </cdr:txBody>
    </cdr:sp>
  </cdr:relSizeAnchor>
  <cdr:relSizeAnchor xmlns:cdr="http://schemas.openxmlformats.org/drawingml/2006/chartDrawing">
    <cdr:from>
      <cdr:x>0.26421</cdr:x>
      <cdr:y>0.10065</cdr:y>
    </cdr:from>
    <cdr:to>
      <cdr:x>0.29053</cdr:x>
      <cdr:y>0.14173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2390732" y="466745"/>
          <a:ext cx="238163" cy="1905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779</cdr:x>
      <cdr:y>0.1561</cdr:y>
    </cdr:from>
    <cdr:to>
      <cdr:x>0.36</cdr:x>
      <cdr:y>0.20129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2514633" y="723903"/>
          <a:ext cx="742903" cy="2095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b b </a:t>
          </a:r>
        </a:p>
      </cdr:txBody>
    </cdr:sp>
  </cdr:relSizeAnchor>
  <cdr:relSizeAnchor xmlns:cdr="http://schemas.openxmlformats.org/drawingml/2006/chartDrawing">
    <cdr:from>
      <cdr:x>0.3179</cdr:x>
      <cdr:y>0.10476</cdr:y>
    </cdr:from>
    <cdr:to>
      <cdr:x>0.35264</cdr:x>
      <cdr:y>0.16227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2876555" y="485786"/>
          <a:ext cx="314353" cy="2666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3474</cdr:x>
      <cdr:y>0.17049</cdr:y>
    </cdr:from>
    <cdr:to>
      <cdr:x>0.40421</cdr:x>
      <cdr:y>0.23416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3028988" y="790597"/>
          <a:ext cx="628617" cy="2952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b b </a:t>
          </a:r>
        </a:p>
      </cdr:txBody>
    </cdr:sp>
  </cdr:relSizeAnchor>
  <cdr:relSizeAnchor xmlns:cdr="http://schemas.openxmlformats.org/drawingml/2006/chartDrawing">
    <cdr:from>
      <cdr:x>0.37368</cdr:x>
      <cdr:y>0.1027</cdr:y>
    </cdr:from>
    <cdr:to>
      <cdr:x>0.39579</cdr:x>
      <cdr:y>0.14172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3381356" y="476270"/>
          <a:ext cx="200068" cy="1809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9579</cdr:x>
      <cdr:y>0.19102</cdr:y>
    </cdr:from>
    <cdr:to>
      <cdr:x>0.41474</cdr:x>
      <cdr:y>0.24031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3581401" y="885825"/>
          <a:ext cx="171450" cy="2285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0105</cdr:x>
      <cdr:y>0.12118</cdr:y>
    </cdr:from>
    <cdr:to>
      <cdr:x>0.44315</cdr:x>
      <cdr:y>0.20334</cdr:y>
    </cdr:to>
    <cdr:sp macro="" textlink="">
      <cdr:nvSpPr>
        <cdr:cNvPr id="16" name="CasellaDiTesto 15"/>
        <cdr:cNvSpPr txBox="1"/>
      </cdr:nvSpPr>
      <cdr:spPr>
        <a:xfrm xmlns:a="http://schemas.openxmlformats.org/drawingml/2006/main" rot="16200000">
          <a:off x="3629010" y="561984"/>
          <a:ext cx="381002" cy="3809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41579</cdr:x>
      <cdr:y>0.16637</cdr:y>
    </cdr:from>
    <cdr:to>
      <cdr:x>0.43158</cdr:x>
      <cdr:y>0.24237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3762370" y="771510"/>
          <a:ext cx="142880" cy="3524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2316</cdr:x>
      <cdr:y>0.19924</cdr:y>
    </cdr:from>
    <cdr:to>
      <cdr:x>0.44105</cdr:x>
      <cdr:y>0.2547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3829079" y="923929"/>
          <a:ext cx="161882" cy="2571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3263</cdr:x>
      <cdr:y>0.1027</cdr:y>
    </cdr:from>
    <cdr:to>
      <cdr:x>0.44948</cdr:x>
      <cdr:y>0.15405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3914732" y="476243"/>
          <a:ext cx="152472" cy="2381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4527</cdr:x>
      <cdr:y>0.13556</cdr:y>
    </cdr:from>
    <cdr:to>
      <cdr:x>0.51474</cdr:x>
      <cdr:y>0.2054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4029113" y="628644"/>
          <a:ext cx="628617" cy="3238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b b </a:t>
          </a:r>
        </a:p>
      </cdr:txBody>
    </cdr:sp>
  </cdr:relSizeAnchor>
  <cdr:relSizeAnchor xmlns:cdr="http://schemas.openxmlformats.org/drawingml/2006/chartDrawing">
    <cdr:from>
      <cdr:x>0.48632</cdr:x>
      <cdr:y>0.10064</cdr:y>
    </cdr:from>
    <cdr:to>
      <cdr:x>0.51474</cdr:x>
      <cdr:y>0.14994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4400579" y="466708"/>
          <a:ext cx="257165" cy="2286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0842</cdr:x>
      <cdr:y>0.22183</cdr:y>
    </cdr:from>
    <cdr:to>
      <cdr:x>0.52632</cdr:x>
      <cdr:y>0.29167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4600570" y="1028686"/>
          <a:ext cx="161973" cy="3238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1685</cdr:x>
      <cdr:y>0.19307</cdr:y>
    </cdr:from>
    <cdr:to>
      <cdr:x>0.53369</cdr:x>
      <cdr:y>0.24442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4676804" y="895335"/>
          <a:ext cx="152381" cy="2381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2737</cdr:x>
      <cdr:y>0.25058</cdr:y>
    </cdr:from>
    <cdr:to>
      <cdr:x>0.54842</cdr:x>
      <cdr:y>0.28961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4772044" y="1162037"/>
          <a:ext cx="190476" cy="1809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3474</cdr:x>
      <cdr:y>0.21772</cdr:y>
    </cdr:from>
    <cdr:to>
      <cdr:x>0.55158</cdr:x>
      <cdr:y>0.2814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4838700" y="1009650"/>
          <a:ext cx="152367" cy="2952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4315</cdr:x>
      <cdr:y>0.09859</cdr:y>
    </cdr:from>
    <cdr:to>
      <cdr:x>0.56736</cdr:x>
      <cdr:y>0.152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4914862" y="457193"/>
          <a:ext cx="219070" cy="2476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8737</cdr:x>
      <cdr:y>0.07394</cdr:y>
    </cdr:from>
    <cdr:to>
      <cdr:x>0.60316</cdr:x>
      <cdr:y>0.11708</cdr:y>
    </cdr:to>
    <cdr:sp macro="" textlink="">
      <cdr:nvSpPr>
        <cdr:cNvPr id="27" name="CasellaDiTesto 26"/>
        <cdr:cNvSpPr txBox="1"/>
      </cdr:nvSpPr>
      <cdr:spPr>
        <a:xfrm xmlns:a="http://schemas.openxmlformats.org/drawingml/2006/main">
          <a:off x="5314974" y="342883"/>
          <a:ext cx="142880" cy="2000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6105</cdr:x>
      <cdr:y>0.10681</cdr:y>
    </cdr:from>
    <cdr:to>
      <cdr:x>0.62421</cdr:x>
      <cdr:y>0.15611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5076801" y="495302"/>
          <a:ext cx="571519" cy="2286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 a </a:t>
          </a:r>
        </a:p>
      </cdr:txBody>
    </cdr:sp>
  </cdr:relSizeAnchor>
  <cdr:relSizeAnchor xmlns:cdr="http://schemas.openxmlformats.org/drawingml/2006/chartDrawing">
    <cdr:from>
      <cdr:x>0.59579</cdr:x>
      <cdr:y>0.10064</cdr:y>
    </cdr:from>
    <cdr:to>
      <cdr:x>0.62316</cdr:x>
      <cdr:y>0.14583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5391112" y="466717"/>
          <a:ext cx="247664" cy="20956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1158</cdr:x>
      <cdr:y>0.14789</cdr:y>
    </cdr:from>
    <cdr:to>
      <cdr:x>0.69264</cdr:x>
      <cdr:y>0.2588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5534001" y="685822"/>
          <a:ext cx="733492" cy="5143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 b b b </a:t>
          </a:r>
        </a:p>
      </cdr:txBody>
    </cdr:sp>
  </cdr:relSizeAnchor>
  <cdr:relSizeAnchor xmlns:cdr="http://schemas.openxmlformats.org/drawingml/2006/chartDrawing">
    <cdr:from>
      <cdr:x>0.65158</cdr:x>
      <cdr:y>0.09859</cdr:y>
    </cdr:from>
    <cdr:to>
      <cdr:x>0.67263</cdr:x>
      <cdr:y>0.13967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5895985" y="457211"/>
          <a:ext cx="190476" cy="1905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263</cdr:x>
      <cdr:y>0.1787</cdr:y>
    </cdr:from>
    <cdr:to>
      <cdr:x>0.69158</cdr:x>
      <cdr:y>0.22799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6086494" y="828688"/>
          <a:ext cx="171474" cy="2285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9053</cdr:x>
      <cdr:y>0.18486</cdr:y>
    </cdr:from>
    <cdr:to>
      <cdr:x>0.71474</cdr:x>
      <cdr:y>0.24032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6248424" y="857245"/>
          <a:ext cx="219070" cy="2571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821</cdr:x>
      <cdr:y>0.12119</cdr:y>
    </cdr:from>
    <cdr:to>
      <cdr:x>0.74316</cdr:x>
      <cdr:y>0.18281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6172167" y="561987"/>
          <a:ext cx="552516" cy="285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  a</a:t>
          </a:r>
        </a:p>
      </cdr:txBody>
    </cdr:sp>
  </cdr:relSizeAnchor>
  <cdr:relSizeAnchor xmlns:cdr="http://schemas.openxmlformats.org/drawingml/2006/chartDrawing">
    <cdr:from>
      <cdr:x>0.70948</cdr:x>
      <cdr:y>0.1027</cdr:y>
    </cdr:from>
    <cdr:to>
      <cdr:x>0.73474</cdr:x>
      <cdr:y>0.15199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6419888" y="476261"/>
          <a:ext cx="228572" cy="2285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2842</cdr:x>
      <cdr:y>0.15816</cdr:y>
    </cdr:from>
    <cdr:to>
      <cdr:x>0.75789</cdr:x>
      <cdr:y>0.21362</cdr:y>
    </cdr:to>
    <cdr:sp macro="" textlink="">
      <cdr:nvSpPr>
        <cdr:cNvPr id="36" name="CasellaDiTesto 35"/>
        <cdr:cNvSpPr txBox="1"/>
      </cdr:nvSpPr>
      <cdr:spPr>
        <a:xfrm xmlns:a="http://schemas.openxmlformats.org/drawingml/2006/main">
          <a:off x="6591300" y="733428"/>
          <a:ext cx="266667" cy="2571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3684</cdr:x>
      <cdr:y>0.10065</cdr:y>
    </cdr:from>
    <cdr:to>
      <cdr:x>0.76631</cdr:x>
      <cdr:y>0.16227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6667514" y="466737"/>
          <a:ext cx="266667" cy="285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4684</cdr:x>
      <cdr:y>0.04827</cdr:y>
    </cdr:from>
    <cdr:to>
      <cdr:x>0.81684</cdr:x>
      <cdr:y>0.15713</cdr:y>
    </cdr:to>
    <cdr:sp macro="" textlink="">
      <cdr:nvSpPr>
        <cdr:cNvPr id="38" name="CasellaDiTesto 37"/>
        <cdr:cNvSpPr txBox="1"/>
      </cdr:nvSpPr>
      <cdr:spPr>
        <a:xfrm xmlns:a="http://schemas.openxmlformats.org/drawingml/2006/main" rot="16200000">
          <a:off x="6822299" y="159556"/>
          <a:ext cx="504818" cy="6334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900"/>
            <a:t>ab </a:t>
          </a:r>
        </a:p>
        <a:p xmlns:a="http://schemas.openxmlformats.org/drawingml/2006/main">
          <a:r>
            <a:rPr lang="fr-FR" sz="900"/>
            <a:t>a </a:t>
          </a:r>
        </a:p>
      </cdr:txBody>
    </cdr:sp>
  </cdr:relSizeAnchor>
  <cdr:relSizeAnchor xmlns:cdr="http://schemas.openxmlformats.org/drawingml/2006/chartDrawing">
    <cdr:from>
      <cdr:x>0.78315</cdr:x>
      <cdr:y>0.18692</cdr:y>
    </cdr:from>
    <cdr:to>
      <cdr:x>0.80736</cdr:x>
      <cdr:y>0.23211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7086567" y="866786"/>
          <a:ext cx="219070" cy="2095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2105</cdr:x>
      <cdr:y>0.10475</cdr:y>
    </cdr:from>
    <cdr:to>
      <cdr:x>0.84421</cdr:x>
      <cdr:y>0.16637</cdr:y>
    </cdr:to>
    <cdr:sp macro="" textlink="">
      <cdr:nvSpPr>
        <cdr:cNvPr id="41" name="CasellaDiTesto 40"/>
        <cdr:cNvSpPr txBox="1"/>
      </cdr:nvSpPr>
      <cdr:spPr>
        <a:xfrm xmlns:a="http://schemas.openxmlformats.org/drawingml/2006/main">
          <a:off x="7429457" y="485779"/>
          <a:ext cx="209569" cy="285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9158</cdr:x>
      <cdr:y>0.11708</cdr:y>
    </cdr:from>
    <cdr:to>
      <cdr:x>0.87158</cdr:x>
      <cdr:y>0.16638</cdr:y>
    </cdr:to>
    <cdr:sp macro="" textlink="">
      <cdr:nvSpPr>
        <cdr:cNvPr id="42" name="CasellaDiTesto 41"/>
        <cdr:cNvSpPr txBox="1"/>
      </cdr:nvSpPr>
      <cdr:spPr>
        <a:xfrm xmlns:a="http://schemas.openxmlformats.org/drawingml/2006/main">
          <a:off x="7162838" y="542918"/>
          <a:ext cx="723900" cy="2286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 a a </a:t>
          </a:r>
        </a:p>
      </cdr:txBody>
    </cdr:sp>
  </cdr:relSizeAnchor>
  <cdr:relSizeAnchor xmlns:cdr="http://schemas.openxmlformats.org/drawingml/2006/chartDrawing">
    <cdr:from>
      <cdr:x>0.87789</cdr:x>
      <cdr:y>0.10065</cdr:y>
    </cdr:from>
    <cdr:to>
      <cdr:x>0.9</cdr:x>
      <cdr:y>0.1561</cdr:y>
    </cdr:to>
    <cdr:sp macro="" textlink="">
      <cdr:nvSpPr>
        <cdr:cNvPr id="43" name="CasellaDiTesto 42"/>
        <cdr:cNvSpPr txBox="1"/>
      </cdr:nvSpPr>
      <cdr:spPr>
        <a:xfrm xmlns:a="http://schemas.openxmlformats.org/drawingml/2006/main">
          <a:off x="7943817" y="466745"/>
          <a:ext cx="200068" cy="2571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4105</cdr:x>
      <cdr:y>0.18897</cdr:y>
    </cdr:from>
    <cdr:to>
      <cdr:x>0.86</cdr:x>
      <cdr:y>0.24853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7610475" y="876301"/>
          <a:ext cx="171431" cy="2762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4737</cdr:x>
      <cdr:y>0.14583</cdr:y>
    </cdr:from>
    <cdr:to>
      <cdr:x>0.87474</cdr:x>
      <cdr:y>0.20745</cdr:y>
    </cdr:to>
    <cdr:sp macro="" textlink="">
      <cdr:nvSpPr>
        <cdr:cNvPr id="45" name="CasellaDiTesto 44"/>
        <cdr:cNvSpPr txBox="1"/>
      </cdr:nvSpPr>
      <cdr:spPr>
        <a:xfrm xmlns:a="http://schemas.openxmlformats.org/drawingml/2006/main">
          <a:off x="7667625" y="676275"/>
          <a:ext cx="247669" cy="2857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5737</cdr:x>
      <cdr:y>0.03184</cdr:y>
    </cdr:from>
    <cdr:to>
      <cdr:x>0.89211</cdr:x>
      <cdr:y>0.20848</cdr:y>
    </cdr:to>
    <cdr:sp macro="" textlink="">
      <cdr:nvSpPr>
        <cdr:cNvPr id="46" name="CasellaDiTesto 45"/>
        <cdr:cNvSpPr txBox="1"/>
      </cdr:nvSpPr>
      <cdr:spPr>
        <a:xfrm xmlns:a="http://schemas.openxmlformats.org/drawingml/2006/main" rot="16200000">
          <a:off x="7505717" y="400034"/>
          <a:ext cx="819135" cy="3143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  <cdr:relSizeAnchor xmlns:cdr="http://schemas.openxmlformats.org/drawingml/2006/chartDrawing">
    <cdr:from>
      <cdr:x>0.86842</cdr:x>
      <cdr:y>0.1561</cdr:y>
    </cdr:from>
    <cdr:to>
      <cdr:x>0.89053</cdr:x>
      <cdr:y>0.21978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7858125" y="723901"/>
          <a:ext cx="200044" cy="2952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5316</cdr:x>
      <cdr:y>0.05238</cdr:y>
    </cdr:from>
    <cdr:to>
      <cdr:x>0.78158</cdr:x>
      <cdr:y>0.13454</cdr:y>
    </cdr:to>
    <cdr:sp macro="" textlink="">
      <cdr:nvSpPr>
        <cdr:cNvPr id="40" name="TextBox 39">
          <a:extLst xmlns:a="http://schemas.openxmlformats.org/drawingml/2006/main">
            <a:ext uri="{FF2B5EF4-FFF2-40B4-BE49-F238E27FC236}">
              <a16:creationId xmlns="" xmlns:a16="http://schemas.microsoft.com/office/drawing/2014/main" id="{03417F3E-E941-4F30-9BC3-817B3B599B10}"/>
            </a:ext>
          </a:extLst>
        </cdr:cNvPr>
        <cdr:cNvSpPr txBox="1"/>
      </cdr:nvSpPr>
      <cdr:spPr>
        <a:xfrm xmlns:a="http://schemas.openxmlformats.org/drawingml/2006/main" rot="16200000">
          <a:off x="6753226" y="304800"/>
          <a:ext cx="381000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b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5868144" y="10684"/>
            <a:ext cx="22004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smtClean="0"/>
              <a:t>Magnolol</a:t>
            </a:r>
            <a:r>
              <a:rPr lang="en-GB" b="1" dirty="0" smtClean="0"/>
              <a:t> </a:t>
            </a:r>
            <a:r>
              <a:rPr lang="en-GB" b="1" dirty="0"/>
              <a:t>diacetate 4</a:t>
            </a:r>
          </a:p>
        </p:txBody>
      </p:sp>
      <p:graphicFrame>
        <p:nvGraphicFramePr>
          <p:cNvPr id="7" name="Grafico 6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300-000003000000}"/>
              </a:ext>
            </a:extLst>
          </p:cNvPr>
          <p:cNvGraphicFramePr>
            <a:graphicFrameLocks/>
          </p:cNvGraphicFramePr>
          <p:nvPr/>
        </p:nvGraphicFramePr>
        <p:xfrm>
          <a:off x="147637" y="1200150"/>
          <a:ext cx="8848725" cy="4457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423268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5</TotalTime>
  <Words>85</Words>
  <Application>Microsoft Office PowerPoint</Application>
  <PresentationFormat>Presentazione su schermo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7:21Z</dcterms:modified>
</cp:coreProperties>
</file>